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6" r:id="rId4"/>
    <p:sldId id="259" r:id="rId5"/>
    <p:sldId id="260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512" y="-72"/>
      </p:cViewPr>
      <p:guideLst>
        <p:guide orient="horz" pos="2158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82AE15-2313-464A-B0C7-5610E6D5AC3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9DB15D-C789-4D85-99C2-E57474F40E0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jpeg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6.jpeg"/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image" Target="../media/image3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323528" y="4509120"/>
            <a:ext cx="8568952" cy="13379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zh-CN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me-wide average decay of linkage disequilibrium with physical distance in the whole population. The scale on the y-axis is the average R square, and the scale on the x-axis represents the physical distance between SNP markers (Kb). </a:t>
            </a:r>
            <a:endParaRPr lang="en-US" altLang="zh-CN" dirty="0" smtClean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" name="图片 1" descr="LD_decay"/>
          <p:cNvPicPr>
            <a:picLocks noChangeAspect="1"/>
          </p:cNvPicPr>
          <p:nvPr/>
        </p:nvPicPr>
        <p:blipFill>
          <a:blip r:embed="rId1"/>
          <a:srcRect l="2512" t="12330" r="3588" b="6497"/>
          <a:stretch>
            <a:fillRect/>
          </a:stretch>
        </p:blipFill>
        <p:spPr>
          <a:xfrm>
            <a:off x="1214120" y="217805"/>
            <a:ext cx="6245860" cy="404939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91440" y="4869160"/>
            <a:ext cx="8964488" cy="13379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tle population structure identified by principle component analysis (PCA). The scale on the x-axis is the first component (PC1), and the scale on the y-axis represents the second component (PC2). Every blu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t represents a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lstein cattle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 descr="PCA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t="12200" r="2881" b="3302"/>
          <a:stretch>
            <a:fillRect/>
          </a:stretch>
        </p:blipFill>
        <p:spPr>
          <a:xfrm>
            <a:off x="921385" y="382270"/>
            <a:ext cx="6634480" cy="432943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ALB QQ图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56920" y="214630"/>
            <a:ext cx="3106279" cy="2880000"/>
          </a:xfrm>
          <a:prstGeom prst="rect">
            <a:avLst/>
          </a:prstGeom>
        </p:spPr>
      </p:pic>
      <p:pic>
        <p:nvPicPr>
          <p:cNvPr id="5" name="图片 4" descr="ALT QQ图"/>
          <p:cNvPicPr>
            <a:picLocks noChangeAspect="1"/>
          </p:cNvPicPr>
          <p:nvPr/>
        </p:nvPicPr>
        <p:blipFill>
          <a:blip r:embed="rId2"/>
          <a:srcRect l="913" r="-1114"/>
          <a:stretch>
            <a:fillRect/>
          </a:stretch>
        </p:blipFill>
        <p:spPr>
          <a:xfrm>
            <a:off x="4752000" y="214630"/>
            <a:ext cx="3168000" cy="2880000"/>
          </a:xfrm>
          <a:prstGeom prst="rect">
            <a:avLst/>
          </a:prstGeom>
        </p:spPr>
      </p:pic>
      <p:pic>
        <p:nvPicPr>
          <p:cNvPr id="7" name="图片 6" descr="VLDL QQ图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63770" y="3535680"/>
            <a:ext cx="3141818" cy="288000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334645" y="212725"/>
            <a:ext cx="29273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zh-CN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258310" y="212725"/>
            <a:ext cx="28448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zh-CN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34645" y="3291205"/>
            <a:ext cx="29273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altLang="zh-CN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250055" y="3291205"/>
            <a:ext cx="29273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altLang="zh-CN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 descr="BHB QQ图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0410" y="3510915"/>
            <a:ext cx="3170555" cy="295656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318135" y="459740"/>
            <a:ext cx="8311515" cy="230695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just"/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. Quantile-Quantile (Q-Q) plot of the significant traits under fixed-effect linear regression model (FLM) and mixed-effect linear model (MLM). (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) Q-Q plot for serum albumin (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LB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); (b) Q-Q plot for alanine transaminase (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LT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); (c) Q-Q plot for β-hydroxybutyric acid (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BHB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); (d) Q-Q plot for very low density lipoprotein (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VLDL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he scale on the y-axis represents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“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- log10(GWAS p-value observations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”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, and scale on the x-axis represents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“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- log10 (GWAS p-value expectations)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”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. The dotted grey line is for line Y = X, blue dotsrepresent GWAS results from FLM, red dotsrepresent results from MLM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REFSHAPE" val="286496780"/>
  <p:tag name="KSO_WM_UNIT_PLACING_PICTURE_USER_VIEWPORT" val="{&quot;height&quot;:6480,&quot;width&quot;:8640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03</Words>
  <Application>WPS 演示</Application>
  <PresentationFormat>全屏显示(4:3)</PresentationFormat>
  <Paragraphs>1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PC</dc:creator>
  <cp:lastModifiedBy>Lenovo</cp:lastModifiedBy>
  <cp:revision>12</cp:revision>
  <dcterms:created xsi:type="dcterms:W3CDTF">2018-11-07T09:17:00Z</dcterms:created>
  <dcterms:modified xsi:type="dcterms:W3CDTF">2020-01-23T01:30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339</vt:lpwstr>
  </property>
</Properties>
</file>